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76" d="100"/>
          <a:sy n="76" d="100"/>
        </p:scale>
        <p:origin x="-1584" y="-84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3C0B15-559C-45D8-818E-6B7A6B8FE7D7}" type="datetimeFigureOut">
              <a:rPr lang="en-US" smtClean="0"/>
              <a:t>1/19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3769A9-02BF-49A8-8B49-1F5207E867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9739211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3C0B15-559C-45D8-818E-6B7A6B8FE7D7}" type="datetimeFigureOut">
              <a:rPr lang="en-US" smtClean="0"/>
              <a:t>1/19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3769A9-02BF-49A8-8B49-1F5207E867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7553615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3C0B15-559C-45D8-818E-6B7A6B8FE7D7}" type="datetimeFigureOut">
              <a:rPr lang="en-US" smtClean="0"/>
              <a:t>1/19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3769A9-02BF-49A8-8B49-1F5207E867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211309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3C0B15-559C-45D8-818E-6B7A6B8FE7D7}" type="datetimeFigureOut">
              <a:rPr lang="en-US" smtClean="0"/>
              <a:t>1/19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3769A9-02BF-49A8-8B49-1F5207E867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156069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3C0B15-559C-45D8-818E-6B7A6B8FE7D7}" type="datetimeFigureOut">
              <a:rPr lang="en-US" smtClean="0"/>
              <a:t>1/19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3769A9-02BF-49A8-8B49-1F5207E867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0849290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3C0B15-559C-45D8-818E-6B7A6B8FE7D7}" type="datetimeFigureOut">
              <a:rPr lang="en-US" smtClean="0"/>
              <a:t>1/19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3769A9-02BF-49A8-8B49-1F5207E867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2160660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3C0B15-559C-45D8-818E-6B7A6B8FE7D7}" type="datetimeFigureOut">
              <a:rPr lang="en-US" smtClean="0"/>
              <a:t>1/19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3769A9-02BF-49A8-8B49-1F5207E867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7717203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3C0B15-559C-45D8-818E-6B7A6B8FE7D7}" type="datetimeFigureOut">
              <a:rPr lang="en-US" smtClean="0"/>
              <a:t>1/19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3769A9-02BF-49A8-8B49-1F5207E867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1105269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3C0B15-559C-45D8-818E-6B7A6B8FE7D7}" type="datetimeFigureOut">
              <a:rPr lang="en-US" smtClean="0"/>
              <a:t>1/19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3769A9-02BF-49A8-8B49-1F5207E867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4441273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3C0B15-559C-45D8-818E-6B7A6B8FE7D7}" type="datetimeFigureOut">
              <a:rPr lang="en-US" smtClean="0"/>
              <a:t>1/19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3769A9-02BF-49A8-8B49-1F5207E867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254726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3C0B15-559C-45D8-818E-6B7A6B8FE7D7}" type="datetimeFigureOut">
              <a:rPr lang="en-US" smtClean="0"/>
              <a:t>1/19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3769A9-02BF-49A8-8B49-1F5207E867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5345307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13C0B15-559C-45D8-818E-6B7A6B8FE7D7}" type="datetimeFigureOut">
              <a:rPr lang="en-US" smtClean="0"/>
              <a:t>1/19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73769A9-02BF-49A8-8B49-1F5207E867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1366224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548680" y="467544"/>
            <a:ext cx="5904656" cy="2016224"/>
          </a:xfrm>
        </p:spPr>
        <p:txBody>
          <a:bodyPr>
            <a:noAutofit/>
          </a:bodyPr>
          <a:lstStyle/>
          <a:p>
            <a:r>
              <a:rPr lang="en-GB" sz="14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 1.</a:t>
            </a:r>
            <a:r>
              <a:rPr lang="en-GB" sz="14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NMR data supporting annotation of methyl signal at 1.0679 ppm as 3-HIB. TOCSY cross-peaks at 2.483, 3.535, and 3.703 ppm are in accordance with the 3-HIB HMDB entry 00023 values of 2.4727, 3.5244, and 3.6844. There is also a very weak signal in the natural abundance of </a:t>
            </a:r>
            <a:r>
              <a:rPr lang="en-GB" sz="1400" baseline="300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en-GB" sz="14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H,</a:t>
            </a:r>
            <a:r>
              <a:rPr lang="en-GB" sz="1400" baseline="300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3</a:t>
            </a:r>
            <a:r>
              <a:rPr lang="en-GB" sz="14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-HSQC at a carbon chemical shift of 16.59 ppm, also in accordance with the 3-HIB methyl carbon shift in HMDB of 16.60 ppm.</a:t>
            </a:r>
            <a:endParaRPr lang="en-US" sz="14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sz="1400" dirty="0">
              <a:solidFill>
                <a:schemeClr val="tx1"/>
              </a:solidFill>
            </a:endParaRPr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8050" y="2339752"/>
            <a:ext cx="6025286" cy="419273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1967778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82</Words>
  <Application>Microsoft Office PowerPoint</Application>
  <PresentationFormat>On-screen Show (4:3)</PresentationFormat>
  <Paragraphs>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Ulrika Andersson Hall</dc:creator>
  <cp:lastModifiedBy>Ulrika Andersson Hall</cp:lastModifiedBy>
  <cp:revision>2</cp:revision>
  <dcterms:created xsi:type="dcterms:W3CDTF">2018-01-19T07:49:10Z</dcterms:created>
  <dcterms:modified xsi:type="dcterms:W3CDTF">2018-01-19T07:51:18Z</dcterms:modified>
</cp:coreProperties>
</file>